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  <p:sldId id="258" r:id="rId6"/>
    <p:sldId id="259" r:id="rId7"/>
    <p:sldId id="260" r:id="rId8"/>
    <p:sldId id="261" r:id="rId9"/>
    <p:sldId id="264" r:id="rId10"/>
    <p:sldId id="262" r:id="rId11"/>
    <p:sldId id="263" r:id="rId12"/>
    <p:sldId id="265" r:id="rId13"/>
    <p:sldId id="266" r:id="rId14"/>
    <p:sldId id="267" r:id="rId15"/>
  </p:sldIdLst>
  <p:sldSz cx="12192000" cy="6858000"/>
  <p:notesSz cx="6858000" cy="9144000"/>
  <p:defaultTextStyle>
    <a:defPPr>
      <a:defRPr lang="en-M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F0F0911-C4BD-0347-9F05-27AAD3CE11DD}" v="2" dt="2024-10-08T18:21:53.2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568"/>
    <p:restoredTop sz="96327"/>
  </p:normalViewPr>
  <p:slideViewPr>
    <p:cSldViewPr snapToGrid="0" snapToObjects="1">
      <p:cViewPr>
        <p:scale>
          <a:sx n="100" d="100"/>
          <a:sy n="100" d="100"/>
        </p:scale>
        <p:origin x="144" y="7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21" Type="http://schemas.microsoft.com/office/2015/10/relationships/revisionInfo" Target="revisionInfo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k Phoya" userId="S::phyfra001@myuct.ac.za::83d8ded4-ddd4-4701-86f9-6e2fffece9c6" providerId="AD" clId="Web-{00FCD790-308A-4AE8-B1D7-9999E510C1A6}"/>
    <pc:docChg chg="modSld">
      <pc:chgData name="Frank Phoya" userId="S::phyfra001@myuct.ac.za::83d8ded4-ddd4-4701-86f9-6e2fffece9c6" providerId="AD" clId="Web-{00FCD790-308A-4AE8-B1D7-9999E510C1A6}" dt="2024-10-07T05:53:32.527" v="4" actId="20577"/>
      <pc:docMkLst>
        <pc:docMk/>
      </pc:docMkLst>
      <pc:sldChg chg="modSp">
        <pc:chgData name="Frank Phoya" userId="S::phyfra001@myuct.ac.za::83d8ded4-ddd4-4701-86f9-6e2fffece9c6" providerId="AD" clId="Web-{00FCD790-308A-4AE8-B1D7-9999E510C1A6}" dt="2024-10-07T05:53:32.527" v="4" actId="20577"/>
        <pc:sldMkLst>
          <pc:docMk/>
          <pc:sldMk cId="3209950384" sldId="256"/>
        </pc:sldMkLst>
        <pc:spChg chg="mod">
          <ac:chgData name="Frank Phoya" userId="S::phyfra001@myuct.ac.za::83d8ded4-ddd4-4701-86f9-6e2fffece9c6" providerId="AD" clId="Web-{00FCD790-308A-4AE8-B1D7-9999E510C1A6}" dt="2024-10-07T05:53:32.527" v="4" actId="20577"/>
          <ac:spMkLst>
            <pc:docMk/>
            <pc:sldMk cId="3209950384" sldId="256"/>
            <ac:spMk id="3" creationId="{72D53236-006F-9247-B4C7-48EEFBC794C6}"/>
          </ac:spMkLst>
        </pc:spChg>
      </pc:sldChg>
    </pc:docChg>
  </pc:docChgLst>
  <pc:docChgLst>
    <pc:chgData name="Kate Webb" userId="4c818f20-880a-464b-bccf-1b8a090edf3c" providerId="ADAL" clId="{4E69FB83-8B2B-354F-B098-8B4550874D2F}"/>
    <pc:docChg chg="custSel addSld modSld modMainMaster">
      <pc:chgData name="Kate Webb" userId="4c818f20-880a-464b-bccf-1b8a090edf3c" providerId="ADAL" clId="{4E69FB83-8B2B-354F-B098-8B4550874D2F}" dt="2024-10-04T12:37:26.822" v="65" actId="478"/>
      <pc:docMkLst>
        <pc:docMk/>
      </pc:docMkLst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3209950384" sldId="256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3209950384" sldId="256"/>
            <ac:spMk id="2" creationId="{1AD0591E-256D-5940-8494-831CF7B59EAE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3209950384" sldId="256"/>
            <ac:spMk id="3" creationId="{72D53236-006F-9247-B4C7-48EEFBC794C6}"/>
          </ac:spMkLst>
        </pc:sp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2757837656" sldId="258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2757837656" sldId="258"/>
            <ac:spMk id="2" creationId="{DFA8AD49-BAD1-7A42-B6FA-547626475DBE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2757837656" sldId="258"/>
            <ac:picMk id="4" creationId="{AF79533A-0F98-364B-A715-3BC7E8CC53FE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1136301288" sldId="259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1136301288" sldId="259"/>
            <ac:spMk id="2" creationId="{1A13C1FA-58F0-ED4B-A24B-FF15A7BF9DFB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1136301288" sldId="259"/>
            <ac:spMk id="6" creationId="{8851AD69-2D7D-FC4D-840D-2220381784FD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1136301288" sldId="259"/>
            <ac:picMk id="4" creationId="{E8BE4AE4-4069-704E-825B-7239C007E027}"/>
          </ac:picMkLst>
        </pc:pic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1136301288" sldId="259"/>
            <ac:picMk id="5" creationId="{4D891347-F72F-9749-90E8-D5ADD3169754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1578818950" sldId="260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1578818950" sldId="260"/>
            <ac:spMk id="2" creationId="{6F5BA4D1-76FC-FD46-AE6C-7D654780EB27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1578818950" sldId="260"/>
            <ac:picMk id="4" creationId="{98AA9017-EBF9-EF48-B1FC-843E1BC8F4C1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1709380377" sldId="261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1709380377" sldId="261"/>
            <ac:spMk id="2" creationId="{E032A6E7-F5F5-484A-AE91-4D1734EC0473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1709380377" sldId="261"/>
            <ac:spMk id="7" creationId="{75EEF5D8-BFA9-274D-9573-48FD4E0E5275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1709380377" sldId="261"/>
            <ac:picMk id="4" creationId="{D91AD295-8289-BC41-B433-8039E28D6D25}"/>
          </ac:picMkLst>
        </pc:pic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1709380377" sldId="261"/>
            <ac:picMk id="6" creationId="{72A2CC5A-CBDE-8E40-B824-EC2E9D005AAD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3292876627" sldId="262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3292876627" sldId="262"/>
            <ac:spMk id="2" creationId="{EA8E8928-B82B-7545-80D6-7E771BA8DD4D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3292876627" sldId="262"/>
            <ac:spMk id="6" creationId="{8BB905B1-6BBA-5340-A384-AF4F306FC6A7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3292876627" sldId="262"/>
            <ac:picMk id="4" creationId="{0DD56963-9158-3647-A37F-D6AF61F27679}"/>
          </ac:picMkLst>
        </pc:pic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3292876627" sldId="262"/>
            <ac:picMk id="5" creationId="{DEBF2AFD-3818-4B44-99E7-7B3F1BCC6531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3927697169" sldId="263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3927697169" sldId="263"/>
            <ac:spMk id="2" creationId="{25B00FE9-C699-1B47-B817-E23E68023481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3927697169" sldId="263"/>
            <ac:picMk id="4" creationId="{6ECA25C3-5229-6140-A1E0-A4B955230088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2810288813" sldId="264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2810288813" sldId="264"/>
            <ac:spMk id="2" creationId="{6B722981-E8AB-CE4E-8957-C99D8B0D82E6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2810288813" sldId="264"/>
            <ac:picMk id="4" creationId="{52245753-0C5C-074E-A034-AF692025F588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180790067" sldId="265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180790067" sldId="265"/>
            <ac:spMk id="2" creationId="{4B57229D-C3B2-8D40-A775-CB3FECAC1126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180790067" sldId="265"/>
            <ac:spMk id="6" creationId="{C659F87A-D9B4-EE45-9AFE-0DD1BB6DD7D9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180790067" sldId="265"/>
            <ac:picMk id="4" creationId="{5B38CEC0-A199-FA46-B3BE-E1DD06CD40EE}"/>
          </ac:picMkLst>
        </pc:pic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180790067" sldId="265"/>
            <ac:picMk id="5" creationId="{FB6BA8FA-E6CA-F04D-A71A-C2E21883308D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2420675562" sldId="266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2420675562" sldId="266"/>
            <ac:spMk id="2" creationId="{DF608892-D5BC-264A-80C6-3E6B94A64206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2420675562" sldId="266"/>
            <ac:picMk id="5" creationId="{71B6CFFA-1F15-054E-A350-BDDD7316D8F2}"/>
          </ac:picMkLst>
        </pc:picChg>
      </pc:sldChg>
      <pc:sldChg chg="modSp">
        <pc:chgData name="Kate Webb" userId="4c818f20-880a-464b-bccf-1b8a090edf3c" providerId="ADAL" clId="{4E69FB83-8B2B-354F-B098-8B4550874D2F}" dt="2024-10-04T12:35:36.089" v="47"/>
        <pc:sldMkLst>
          <pc:docMk/>
          <pc:sldMk cId="240433206" sldId="267"/>
        </pc:sld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240433206" sldId="267"/>
            <ac:spMk id="2" creationId="{5CB8C21A-034F-4E45-A60D-EF707DDFD53A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k cId="240433206" sldId="267"/>
            <ac:spMk id="5" creationId="{47569FB4-1B3A-3C41-A20C-613B0176A3AE}"/>
          </ac:spMkLst>
        </pc:spChg>
        <pc:picChg chg="mod">
          <ac:chgData name="Kate Webb" userId="4c818f20-880a-464b-bccf-1b8a090edf3c" providerId="ADAL" clId="{4E69FB83-8B2B-354F-B098-8B4550874D2F}" dt="2024-10-04T12:35:36.089" v="47"/>
          <ac:picMkLst>
            <pc:docMk/>
            <pc:sldMk cId="240433206" sldId="267"/>
            <ac:picMk id="4" creationId="{724DD41C-9A1D-E740-ACBF-70758F9745C2}"/>
          </ac:picMkLst>
        </pc:picChg>
      </pc:sldChg>
      <pc:sldChg chg="addSp delSp modSp new mod">
        <pc:chgData name="Kate Webb" userId="4c818f20-880a-464b-bccf-1b8a090edf3c" providerId="ADAL" clId="{4E69FB83-8B2B-354F-B098-8B4550874D2F}" dt="2024-10-04T12:37:26.822" v="65" actId="478"/>
        <pc:sldMkLst>
          <pc:docMk/>
          <pc:sldMk cId="2795764335" sldId="268"/>
        </pc:sldMkLst>
        <pc:spChg chg="del mod">
          <ac:chgData name="Kate Webb" userId="4c818f20-880a-464b-bccf-1b8a090edf3c" providerId="ADAL" clId="{4E69FB83-8B2B-354F-B098-8B4550874D2F}" dt="2024-10-04T12:37:26.822" v="65" actId="478"/>
          <ac:spMkLst>
            <pc:docMk/>
            <pc:sldMk cId="2795764335" sldId="268"/>
            <ac:spMk id="2" creationId="{D52623AA-F0AE-CC79-A6A4-85C6F63B4D65}"/>
          </ac:spMkLst>
        </pc:spChg>
        <pc:spChg chg="del">
          <ac:chgData name="Kate Webb" userId="4c818f20-880a-464b-bccf-1b8a090edf3c" providerId="ADAL" clId="{4E69FB83-8B2B-354F-B098-8B4550874D2F}" dt="2024-10-04T12:30:37.807" v="1"/>
          <ac:spMkLst>
            <pc:docMk/>
            <pc:sldMk cId="2795764335" sldId="268"/>
            <ac:spMk id="3" creationId="{1E6A276C-C266-12A5-3BF8-7BAE8A10A6AD}"/>
          </ac:spMkLst>
        </pc:spChg>
        <pc:picChg chg="add mod">
          <ac:chgData name="Kate Webb" userId="4c818f20-880a-464b-bccf-1b8a090edf3c" providerId="ADAL" clId="{4E69FB83-8B2B-354F-B098-8B4550874D2F}" dt="2024-10-04T12:36:23.656" v="52" actId="1076"/>
          <ac:picMkLst>
            <pc:docMk/>
            <pc:sldMk cId="2795764335" sldId="268"/>
            <ac:picMk id="4" creationId="{92FA113A-7B95-871C-2CAC-4C24F2733268}"/>
          </ac:picMkLst>
        </pc:picChg>
        <pc:picChg chg="add mod">
          <ac:chgData name="Kate Webb" userId="4c818f20-880a-464b-bccf-1b8a090edf3c" providerId="ADAL" clId="{4E69FB83-8B2B-354F-B098-8B4550874D2F}" dt="2024-10-04T12:37:00.690" v="59" actId="1076"/>
          <ac:picMkLst>
            <pc:docMk/>
            <pc:sldMk cId="2795764335" sldId="268"/>
            <ac:picMk id="5" creationId="{07904285-F4D7-0F23-7D7A-106875AA987A}"/>
          </ac:picMkLst>
        </pc:picChg>
        <pc:picChg chg="add mod">
          <ac:chgData name="Kate Webb" userId="4c818f20-880a-464b-bccf-1b8a090edf3c" providerId="ADAL" clId="{4E69FB83-8B2B-354F-B098-8B4550874D2F}" dt="2024-10-04T12:37:06.639" v="61" actId="1076"/>
          <ac:picMkLst>
            <pc:docMk/>
            <pc:sldMk cId="2795764335" sldId="268"/>
            <ac:picMk id="6" creationId="{42F9DB8D-1A64-48D3-6FBD-5AB6B5A0F6FB}"/>
          </ac:picMkLst>
        </pc:picChg>
        <pc:picChg chg="add mod">
          <ac:chgData name="Kate Webb" userId="4c818f20-880a-464b-bccf-1b8a090edf3c" providerId="ADAL" clId="{4E69FB83-8B2B-354F-B098-8B4550874D2F}" dt="2024-10-04T12:37:09.438" v="62" actId="1076"/>
          <ac:picMkLst>
            <pc:docMk/>
            <pc:sldMk cId="2795764335" sldId="268"/>
            <ac:picMk id="7" creationId="{BA0D6E22-88CB-4E94-DD80-93EC7794C05E}"/>
          </ac:picMkLst>
        </pc:picChg>
        <pc:picChg chg="add mod">
          <ac:chgData name="Kate Webb" userId="4c818f20-880a-464b-bccf-1b8a090edf3c" providerId="ADAL" clId="{4E69FB83-8B2B-354F-B098-8B4550874D2F}" dt="2024-10-04T12:37:20.089" v="64" actId="14100"/>
          <ac:picMkLst>
            <pc:docMk/>
            <pc:sldMk cId="2795764335" sldId="268"/>
            <ac:picMk id="8" creationId="{5B553B95-4ADB-05CD-5911-BDF843165C93}"/>
          </ac:picMkLst>
        </pc:picChg>
      </pc:sldChg>
      <pc:sldMasterChg chg="modSp modSldLayout">
        <pc:chgData name="Kate Webb" userId="4c818f20-880a-464b-bccf-1b8a090edf3c" providerId="ADAL" clId="{4E69FB83-8B2B-354F-B098-8B4550874D2F}" dt="2024-10-04T12:35:36.089" v="47"/>
        <pc:sldMasterMkLst>
          <pc:docMk/>
          <pc:sldMasterMk cId="1494499741" sldId="2147483648"/>
        </pc:sldMasterMkLst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asterMk cId="1494499741" sldId="2147483648"/>
            <ac:spMk id="2" creationId="{883A0418-C3D8-184D-B8AC-3D5335F88C93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asterMk cId="1494499741" sldId="2147483648"/>
            <ac:spMk id="3" creationId="{BFA249A0-08EB-ED41-8869-3253B790C881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asterMk cId="1494499741" sldId="2147483648"/>
            <ac:spMk id="4" creationId="{7AB41677-2828-9543-90C2-E68964967298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asterMk cId="1494499741" sldId="2147483648"/>
            <ac:spMk id="5" creationId="{7369F2AC-FB9B-E547-B6F6-1B4289A5C670}"/>
          </ac:spMkLst>
        </pc:spChg>
        <pc:spChg chg="mod">
          <ac:chgData name="Kate Webb" userId="4c818f20-880a-464b-bccf-1b8a090edf3c" providerId="ADAL" clId="{4E69FB83-8B2B-354F-B098-8B4550874D2F}" dt="2024-10-04T12:35:36.089" v="47"/>
          <ac:spMkLst>
            <pc:docMk/>
            <pc:sldMasterMk cId="1494499741" sldId="2147483648"/>
            <ac:spMk id="6" creationId="{680534C0-1831-FC4B-A78C-E830FABF99A6}"/>
          </ac:spMkLst>
        </pc:spChg>
        <pc:sldLayoutChg chg="modSp">
          <pc:chgData name="Kate Webb" userId="4c818f20-880a-464b-bccf-1b8a090edf3c" providerId="ADAL" clId="{4E69FB83-8B2B-354F-B098-8B4550874D2F}" dt="2024-10-04T12:35:36.089" v="47"/>
          <pc:sldLayoutMkLst>
            <pc:docMk/>
            <pc:sldMasterMk cId="1494499741" sldId="2147483648"/>
            <pc:sldLayoutMk cId="393732089" sldId="2147483649"/>
          </pc:sldLayoutMkLst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393732089" sldId="2147483649"/>
              <ac:spMk id="2" creationId="{4564A18D-B56F-BA46-BF65-7C0A9CA4146A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393732089" sldId="2147483649"/>
              <ac:spMk id="3" creationId="{A775D90B-040A-8645-B969-14FEB52C469D}"/>
            </ac:spMkLst>
          </pc:spChg>
        </pc:sldLayoutChg>
        <pc:sldLayoutChg chg="modSp">
          <pc:chgData name="Kate Webb" userId="4c818f20-880a-464b-bccf-1b8a090edf3c" providerId="ADAL" clId="{4E69FB83-8B2B-354F-B098-8B4550874D2F}" dt="2024-10-04T12:35:36.089" v="47"/>
          <pc:sldLayoutMkLst>
            <pc:docMk/>
            <pc:sldMasterMk cId="1494499741" sldId="2147483648"/>
            <pc:sldLayoutMk cId="2879969906" sldId="2147483651"/>
          </pc:sldLayoutMkLst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2879969906" sldId="2147483651"/>
              <ac:spMk id="2" creationId="{F4EE48B8-C09D-3E48-83EE-1AEEC2368F9B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2879969906" sldId="2147483651"/>
              <ac:spMk id="3" creationId="{80228E4E-AB06-EA48-B965-E257DB1F2EBB}"/>
            </ac:spMkLst>
          </pc:spChg>
        </pc:sldLayoutChg>
        <pc:sldLayoutChg chg="modSp">
          <pc:chgData name="Kate Webb" userId="4c818f20-880a-464b-bccf-1b8a090edf3c" providerId="ADAL" clId="{4E69FB83-8B2B-354F-B098-8B4550874D2F}" dt="2024-10-04T12:35:36.089" v="47"/>
          <pc:sldLayoutMkLst>
            <pc:docMk/>
            <pc:sldMasterMk cId="1494499741" sldId="2147483648"/>
            <pc:sldLayoutMk cId="99659386" sldId="2147483652"/>
          </pc:sldLayoutMkLst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99659386" sldId="2147483652"/>
              <ac:spMk id="3" creationId="{D9246BC0-C62A-7448-B97B-BB05AD0921E7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99659386" sldId="2147483652"/>
              <ac:spMk id="4" creationId="{259D8085-8DF7-604B-A63F-C68FB45DD7F8}"/>
            </ac:spMkLst>
          </pc:spChg>
        </pc:sldLayoutChg>
        <pc:sldLayoutChg chg="modSp">
          <pc:chgData name="Kate Webb" userId="4c818f20-880a-464b-bccf-1b8a090edf3c" providerId="ADAL" clId="{4E69FB83-8B2B-354F-B098-8B4550874D2F}" dt="2024-10-04T12:35:36.089" v="47"/>
          <pc:sldLayoutMkLst>
            <pc:docMk/>
            <pc:sldMasterMk cId="1494499741" sldId="2147483648"/>
            <pc:sldLayoutMk cId="2677592056" sldId="2147483653"/>
          </pc:sldLayoutMkLst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2677592056" sldId="2147483653"/>
              <ac:spMk id="2" creationId="{D3645532-72AB-A54A-B470-719905158F3D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2677592056" sldId="2147483653"/>
              <ac:spMk id="3" creationId="{2DCCCE8D-A8CA-2C46-9C27-BBFBC0464B6A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2677592056" sldId="2147483653"/>
              <ac:spMk id="4" creationId="{11F13280-C29E-5D47-B5A8-FEE89068EEF4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2677592056" sldId="2147483653"/>
              <ac:spMk id="5" creationId="{C0F50D87-ABD5-6C49-B408-BC0A773958F7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2677592056" sldId="2147483653"/>
              <ac:spMk id="6" creationId="{47037226-1CA4-4349-9658-71E2D19CDE6A}"/>
            </ac:spMkLst>
          </pc:spChg>
        </pc:sldLayoutChg>
        <pc:sldLayoutChg chg="modSp">
          <pc:chgData name="Kate Webb" userId="4c818f20-880a-464b-bccf-1b8a090edf3c" providerId="ADAL" clId="{4E69FB83-8B2B-354F-B098-8B4550874D2F}" dt="2024-10-04T12:35:36.089" v="47"/>
          <pc:sldLayoutMkLst>
            <pc:docMk/>
            <pc:sldMasterMk cId="1494499741" sldId="2147483648"/>
            <pc:sldLayoutMk cId="960730031" sldId="2147483656"/>
          </pc:sldLayoutMkLst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960730031" sldId="2147483656"/>
              <ac:spMk id="2" creationId="{0639A155-F16B-1940-9FC8-EAB2127BFB0F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960730031" sldId="2147483656"/>
              <ac:spMk id="3" creationId="{8FDAA17E-5052-834A-AEC4-79BAE72EDF1C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960730031" sldId="2147483656"/>
              <ac:spMk id="4" creationId="{F8247EBB-7594-4940-B6AE-76336B48124B}"/>
            </ac:spMkLst>
          </pc:spChg>
        </pc:sldLayoutChg>
        <pc:sldLayoutChg chg="modSp">
          <pc:chgData name="Kate Webb" userId="4c818f20-880a-464b-bccf-1b8a090edf3c" providerId="ADAL" clId="{4E69FB83-8B2B-354F-B098-8B4550874D2F}" dt="2024-10-04T12:35:36.089" v="47"/>
          <pc:sldLayoutMkLst>
            <pc:docMk/>
            <pc:sldMasterMk cId="1494499741" sldId="2147483648"/>
            <pc:sldLayoutMk cId="1957697502" sldId="2147483657"/>
          </pc:sldLayoutMkLst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1957697502" sldId="2147483657"/>
              <ac:spMk id="2" creationId="{29AA150B-7F4D-F945-B45A-6A39D4C3C7AB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1957697502" sldId="2147483657"/>
              <ac:spMk id="3" creationId="{AE6E5EA9-EABD-C94F-81E6-6D752FF76393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1957697502" sldId="2147483657"/>
              <ac:spMk id="4" creationId="{2FF67AE2-44FD-3742-A4EB-680DD3B4CE35}"/>
            </ac:spMkLst>
          </pc:spChg>
        </pc:sldLayoutChg>
        <pc:sldLayoutChg chg="modSp">
          <pc:chgData name="Kate Webb" userId="4c818f20-880a-464b-bccf-1b8a090edf3c" providerId="ADAL" clId="{4E69FB83-8B2B-354F-B098-8B4550874D2F}" dt="2024-10-04T12:35:36.089" v="47"/>
          <pc:sldLayoutMkLst>
            <pc:docMk/>
            <pc:sldMasterMk cId="1494499741" sldId="2147483648"/>
            <pc:sldLayoutMk cId="1353695240" sldId="2147483659"/>
          </pc:sldLayoutMkLst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1353695240" sldId="2147483659"/>
              <ac:spMk id="2" creationId="{2A877961-F5D8-FC4F-B454-7B00523D0629}"/>
            </ac:spMkLst>
          </pc:spChg>
          <pc:spChg chg="mod">
            <ac:chgData name="Kate Webb" userId="4c818f20-880a-464b-bccf-1b8a090edf3c" providerId="ADAL" clId="{4E69FB83-8B2B-354F-B098-8B4550874D2F}" dt="2024-10-04T12:35:36.089" v="47"/>
            <ac:spMkLst>
              <pc:docMk/>
              <pc:sldMasterMk cId="1494499741" sldId="2147483648"/>
              <pc:sldLayoutMk cId="1353695240" sldId="2147483659"/>
              <ac:spMk id="3" creationId="{F9F6E329-46F2-4F44-9FB7-705460D2CFC0}"/>
            </ac:spMkLst>
          </pc:spChg>
        </pc:sldLayoutChg>
      </pc:sldMasterChg>
    </pc:docChg>
  </pc:docChgLst>
  <pc:docChgLst>
    <pc:chgData name="Frank Phoya" userId="S::phyfra001@myuct.ac.za::83d8ded4-ddd4-4701-86f9-6e2fffece9c6" providerId="AD" clId="Web-{9E693440-8230-4E67-8F86-6B5433F26BEF}"/>
    <pc:docChg chg="delSld modSld">
      <pc:chgData name="Frank Phoya" userId="S::phyfra001@myuct.ac.za::83d8ded4-ddd4-4701-86f9-6e2fffece9c6" providerId="AD" clId="Web-{9E693440-8230-4E67-8F86-6B5433F26BEF}" dt="2024-10-06T09:30:08.292" v="21" actId="20577"/>
      <pc:docMkLst>
        <pc:docMk/>
      </pc:docMkLst>
      <pc:sldChg chg="modSp">
        <pc:chgData name="Frank Phoya" userId="S::phyfra001@myuct.ac.za::83d8ded4-ddd4-4701-86f9-6e2fffece9c6" providerId="AD" clId="Web-{9E693440-8230-4E67-8F86-6B5433F26BEF}" dt="2024-10-06T09:30:08.292" v="21" actId="20577"/>
        <pc:sldMkLst>
          <pc:docMk/>
          <pc:sldMk cId="3209950384" sldId="256"/>
        </pc:sldMkLst>
        <pc:spChg chg="mod">
          <ac:chgData name="Frank Phoya" userId="S::phyfra001@myuct.ac.za::83d8ded4-ddd4-4701-86f9-6e2fffece9c6" providerId="AD" clId="Web-{9E693440-8230-4E67-8F86-6B5433F26BEF}" dt="2024-10-06T09:29:02.682" v="3" actId="20577"/>
          <ac:spMkLst>
            <pc:docMk/>
            <pc:sldMk cId="3209950384" sldId="256"/>
            <ac:spMk id="2" creationId="{1AD0591E-256D-5940-8494-831CF7B59EAE}"/>
          </ac:spMkLst>
        </pc:spChg>
        <pc:spChg chg="mod">
          <ac:chgData name="Frank Phoya" userId="S::phyfra001@myuct.ac.za::83d8ded4-ddd4-4701-86f9-6e2fffece9c6" providerId="AD" clId="Web-{9E693440-8230-4E67-8F86-6B5433F26BEF}" dt="2024-10-06T09:30:08.292" v="21" actId="20577"/>
          <ac:spMkLst>
            <pc:docMk/>
            <pc:sldMk cId="3209950384" sldId="256"/>
            <ac:spMk id="3" creationId="{72D53236-006F-9247-B4C7-48EEFBC794C6}"/>
          </ac:spMkLst>
        </pc:spChg>
      </pc:sldChg>
      <pc:sldChg chg="del">
        <pc:chgData name="Frank Phoya" userId="S::phyfra001@myuct.ac.za::83d8ded4-ddd4-4701-86f9-6e2fffece9c6" providerId="AD" clId="Web-{9E693440-8230-4E67-8F86-6B5433F26BEF}" dt="2024-10-06T09:28:25.415" v="0"/>
        <pc:sldMkLst>
          <pc:docMk/>
          <pc:sldMk cId="2795764335" sldId="268"/>
        </pc:sldMkLst>
      </pc:sldChg>
    </pc:docChg>
  </pc:docChgLst>
  <pc:docChgLst>
    <pc:chgData name="Frank Phoya" userId="83d8ded4-ddd4-4701-86f9-6e2fffece9c6" providerId="ADAL" clId="{2F0F0911-C4BD-0347-9F05-27AAD3CE11DD}"/>
    <pc:docChg chg="custSel addSld delSld modSld">
      <pc:chgData name="Frank Phoya" userId="83d8ded4-ddd4-4701-86f9-6e2fffece9c6" providerId="ADAL" clId="{2F0F0911-C4BD-0347-9F05-27AAD3CE11DD}" dt="2024-10-08T18:23:46.135" v="24" actId="2696"/>
      <pc:docMkLst>
        <pc:docMk/>
      </pc:docMkLst>
      <pc:sldChg chg="modSp mod">
        <pc:chgData name="Frank Phoya" userId="83d8ded4-ddd4-4701-86f9-6e2fffece9c6" providerId="ADAL" clId="{2F0F0911-C4BD-0347-9F05-27AAD3CE11DD}" dt="2024-10-08T18:19:33.669" v="3" actId="255"/>
        <pc:sldMkLst>
          <pc:docMk/>
          <pc:sldMk cId="3209950384" sldId="256"/>
        </pc:sldMkLst>
        <pc:spChg chg="mod">
          <ac:chgData name="Frank Phoya" userId="83d8ded4-ddd4-4701-86f9-6e2fffece9c6" providerId="ADAL" clId="{2F0F0911-C4BD-0347-9F05-27AAD3CE11DD}" dt="2024-10-08T18:19:33.669" v="3" actId="255"/>
          <ac:spMkLst>
            <pc:docMk/>
            <pc:sldMk cId="3209950384" sldId="256"/>
            <ac:spMk id="2" creationId="{1AD0591E-256D-5940-8494-831CF7B59EAE}"/>
          </ac:spMkLst>
        </pc:spChg>
      </pc:sldChg>
      <pc:sldChg chg="addSp delSp modSp new del mod">
        <pc:chgData name="Frank Phoya" userId="83d8ded4-ddd4-4701-86f9-6e2fffece9c6" providerId="ADAL" clId="{2F0F0911-C4BD-0347-9F05-27AAD3CE11DD}" dt="2024-10-08T18:23:46.135" v="24" actId="2696"/>
        <pc:sldMkLst>
          <pc:docMk/>
          <pc:sldMk cId="546827279" sldId="268"/>
        </pc:sldMkLst>
        <pc:spChg chg="del">
          <ac:chgData name="Frank Phoya" userId="83d8ded4-ddd4-4701-86f9-6e2fffece9c6" providerId="ADAL" clId="{2F0F0911-C4BD-0347-9F05-27AAD3CE11DD}" dt="2024-10-08T18:20:40.087" v="10" actId="478"/>
          <ac:spMkLst>
            <pc:docMk/>
            <pc:sldMk cId="546827279" sldId="268"/>
            <ac:spMk id="2" creationId="{3A29CFF3-E24F-1649-9E6A-C4A0441CD218}"/>
          </ac:spMkLst>
        </pc:spChg>
        <pc:spChg chg="del">
          <ac:chgData name="Frank Phoya" userId="83d8ded4-ddd4-4701-86f9-6e2fffece9c6" providerId="ADAL" clId="{2F0F0911-C4BD-0347-9F05-27AAD3CE11DD}" dt="2024-10-08T18:20:20.438" v="5" actId="478"/>
          <ac:spMkLst>
            <pc:docMk/>
            <pc:sldMk cId="546827279" sldId="268"/>
            <ac:spMk id="3" creationId="{E671BFA0-CC52-A14E-B326-ADDB14CD60B9}"/>
          </ac:spMkLst>
        </pc:spChg>
        <pc:spChg chg="add mod">
          <ac:chgData name="Frank Phoya" userId="83d8ded4-ddd4-4701-86f9-6e2fffece9c6" providerId="ADAL" clId="{2F0F0911-C4BD-0347-9F05-27AAD3CE11DD}" dt="2024-10-08T18:22:14.902" v="16" actId="20577"/>
          <ac:spMkLst>
            <pc:docMk/>
            <pc:sldMk cId="546827279" sldId="268"/>
            <ac:spMk id="5" creationId="{D39B114B-E106-3C43-9A08-72FC42D1E638}"/>
          </ac:spMkLst>
        </pc:spChg>
        <pc:picChg chg="add mod">
          <ac:chgData name="Frank Phoya" userId="83d8ded4-ddd4-4701-86f9-6e2fffece9c6" providerId="ADAL" clId="{2F0F0911-C4BD-0347-9F05-27AAD3CE11DD}" dt="2024-10-08T18:22:45.844" v="23" actId="1076"/>
          <ac:picMkLst>
            <pc:docMk/>
            <pc:sldMk cId="546827279" sldId="268"/>
            <ac:picMk id="4" creationId="{441FC483-5B7C-1F45-AACF-319B18F2B26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4A18D-B56F-BA46-BF65-7C0A9CA414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75D90B-040A-8645-B969-14FEB52C46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MW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D5A96C-8C5F-774D-A462-49BE9C4DB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6E853A-BB5E-CF40-BAE2-7C9BD72E7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1DBE71-DED5-4644-A8ED-9A8440BF4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393732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C9E004-6CA0-7F49-A1DB-14FDD8EBE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8EC150-4424-3640-9469-76CE396874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6E64EA-B080-F140-83C8-ABEF9E7D5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8D0C23-E994-2349-9AB2-7C6623093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9D39B2-7F9B-6E46-8450-D1BBC2382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3622181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877961-F5D8-FC4F-B454-7B00523D06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F6E329-46F2-4F44-9FB7-705460D2CF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F11A4C-5587-F44E-8BD2-1B2A20877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820131-EC44-9C4D-A47B-2DC1F7E0A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BEA6C6-9967-F94E-9E5A-BA18D6E9D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1353695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BBC5-AE93-104B-BD22-3099FA513F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7665AE-2F8B-0D47-8106-C6D66720C1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775726-34AC-DA48-A518-4A787445E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2ADDD-0B4B-C84F-B23F-9749BDEAF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85F8E3-6544-F24A-9502-D9B186AEC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2899062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E48B8-C09D-3E48-83EE-1AEEC2368F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228E4E-AB06-EA48-B965-E257DB1F2E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741AF7-AD01-4C46-9632-A88A2284A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ADBF87-A97B-5F47-BBEA-5E562CE7F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B502C-CDDF-CC49-B515-AC6863B02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2879969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5987AC-2A6C-0240-9605-D5870317B9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246BC0-C62A-7448-B97B-BB05AD0921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9D8085-8DF7-604B-A63F-C68FB45DD7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372BD1-17FB-9A42-BE57-549E3E4B8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EEF236-2227-444C-84DA-97D03F714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2C4E5D-7370-0748-B938-BE3B23A5E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99659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45532-72AB-A54A-B470-719905158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CCCE8D-A8CA-2C46-9C27-BBFBC0464B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F13280-C29E-5D47-B5A8-FEE89068EE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F50D87-ABD5-6C49-B408-BC0A773958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037226-1CA4-4349-9658-71E2D19CDE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7C612F-929F-AA40-9305-59EB73090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AFF9E2-4383-AE47-94F7-B432A6E9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A34BE4-FF67-224E-8CFD-A1986110D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2677592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160E9-BD87-794C-8B87-0DC17283F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061973-7B1B-E94C-ADC2-EF37F8C22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576996-118A-7344-B0F8-A8E1ECDB5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BBEACF-2D44-A246-AF39-47DB49F54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2799961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CC379C-2A1C-1342-B5FC-F022E1ACB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9B5072-85AC-8F48-9F82-5C4B786D8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D831E9F-AFE3-0C4B-A6BC-85D8A066C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1632398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39A155-F16B-1940-9FC8-EAB2127BF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DAA17E-5052-834A-AEC4-79BAE72EDF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247EBB-7594-4940-B6AE-76336B4812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ED7C86-7588-1B4C-981D-3DFF637A4A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72D653-0764-264D-9CBF-5D7E08836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EC5327-2F63-7741-A5DA-260C260DF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960730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AA150B-7F4D-F945-B45A-6A39D4C3C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E6E5EA9-EABD-C94F-81E6-6D752FF763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MW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F67AE2-44FD-3742-A4EB-680DD3B4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AD33C1-6BFB-AD4D-BBA9-6B266F71B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F98E59-E834-F846-A110-0A162FE2E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W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95E4CD-ECF2-F143-9FDE-732F2624C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1957697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3A0418-C3D8-184D-B8AC-3D5335F88C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MW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A249A0-08EB-ED41-8869-3253B790C8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MW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B41677-2828-9543-90C2-E689649672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E1D76-B375-FD4B-9CAD-FAEDC88A4DD7}" type="datetimeFigureOut">
              <a:rPr lang="en-MW" smtClean="0"/>
              <a:t>08/10/2024</a:t>
            </a:fld>
            <a:endParaRPr lang="en-MW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69F2AC-FB9B-E547-B6F6-1B4289A5C6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W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0534C0-1831-FC4B-A78C-E830FABF99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01BF0-9830-8143-853C-55EBE3A21DDD}" type="slidenum">
              <a:rPr lang="en-MW" smtClean="0"/>
              <a:t>‹#›</a:t>
            </a:fld>
            <a:endParaRPr lang="en-MW"/>
          </a:p>
        </p:txBody>
      </p:sp>
    </p:spTree>
    <p:extLst>
      <p:ext uri="{BB962C8B-B14F-4D97-AF65-F5344CB8AC3E}">
        <p14:creationId xmlns:p14="http://schemas.microsoft.com/office/powerpoint/2010/main" val="1494499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M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D0591E-256D-5940-8494-831CF7B59EA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GB" sz="1800" b="1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edium term health and quality of life outcomes in a cohort of children with MIS-C in Cape Town, South Africa</a:t>
            </a:r>
            <a:r>
              <a:rPr lang="en-US" sz="1800" b="1" u="sng" dirty="0">
                <a:ea typeface="+mj-lt"/>
                <a:cs typeface="+mj-lt"/>
              </a:rPr>
              <a:t>. 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sz="1600" dirty="0">
              <a:ea typeface="Calibri Light"/>
              <a:cs typeface="Calibri Light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D53236-006F-9247-B4C7-48EEFBC794C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r>
              <a:rPr lang="en-GB" sz="1800"/>
              <a:t>S</a:t>
            </a:r>
            <a:r>
              <a:rPr lang="en-MW" sz="1800"/>
              <a:t>upplementary</a:t>
            </a:r>
            <a:r>
              <a:rPr lang="en-MW" sz="1800" dirty="0"/>
              <a:t> figures and Tables </a:t>
            </a:r>
          </a:p>
        </p:txBody>
      </p:sp>
    </p:spTree>
    <p:extLst>
      <p:ext uri="{BB962C8B-B14F-4D97-AF65-F5344CB8AC3E}">
        <p14:creationId xmlns:p14="http://schemas.microsoft.com/office/powerpoint/2010/main" val="32099503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608892-D5BC-264A-80C6-3E6B94A64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6. Quality of life assessment psychosocial functioning score comparison between MIS-C and JIA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1B6CFFA-1F15-054E-A350-BDDD7316D8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135792"/>
            <a:ext cx="9375174" cy="4586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067556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B8C21A-034F-4E45-A60D-EF707DDFD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6. 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24DD41C-9A1D-E740-ACBF-70758F9745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56" y="1016027"/>
            <a:ext cx="8029891" cy="44864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7569FB4-1B3A-3C41-A20C-613B0176A3AE}"/>
              </a:ext>
            </a:extLst>
          </p:cNvPr>
          <p:cNvSpPr txBox="1"/>
          <p:nvPr/>
        </p:nvSpPr>
        <p:spPr>
          <a:xfrm rot="10800000" flipV="1">
            <a:off x="838200" y="5456316"/>
            <a:ext cx="52578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lity of life assessment, psychosocial functioning score MIS-C and JIA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S-C- Blue, JIA-Green</a:t>
            </a: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ars represent the number of patients with a particular percentage score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433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A8AD49-BAD1-7A42-B6FA-547626475D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2. Quality of life assessment physical functioning score comparison between MIS-C and JIA 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79533A-0F98-364B-A715-3BC7E8CC53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2" y="1027908"/>
            <a:ext cx="8123555" cy="5708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78376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3C1FA-58F0-ED4B-A24B-FF15A7BF9D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2. 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8BE4AE4-4069-704E-825B-7239C007E02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2340" y="1390245"/>
            <a:ext cx="6096000" cy="32520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D891347-F72F-9749-90E8-D5ADD31697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00455"/>
            <a:ext cx="6169660" cy="41681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851AD69-2D7D-FC4D-840D-2220381784FD}"/>
              </a:ext>
            </a:extLst>
          </p:cNvPr>
          <p:cNvSpPr txBox="1"/>
          <p:nvPr/>
        </p:nvSpPr>
        <p:spPr>
          <a:xfrm flipH="1">
            <a:off x="-1" y="5400765"/>
            <a:ext cx="783418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lity of life assessment physical functioning score MIS-C and JIA 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S-C- Blue, JIA-Green</a:t>
            </a: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ars represent the number of patients with a particular percentage score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63012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5BA4D1-76FC-FD46-AE6C-7D654780E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3. Quality of life assessment emotional functioning score comparison between MIS-C and JIA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8AA9017-EBF9-EF48-B1FC-843E1BC8F4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235678"/>
            <a:ext cx="8724302" cy="52571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88189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2A6E7-F5F5-484A-AE91-4D1734EC04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3. 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91AD295-8289-BC41-B433-8039E28D6D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7105" y="1872082"/>
            <a:ext cx="6093411" cy="3182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2A2CC5A-CBDE-8E40-B824-EC2E9D005A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72" y="1702882"/>
            <a:ext cx="5503633" cy="35208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5EEF5D8-BFA9-274D-9573-48FD4E0E5275}"/>
              </a:ext>
            </a:extLst>
          </p:cNvPr>
          <p:cNvSpPr txBox="1"/>
          <p:nvPr/>
        </p:nvSpPr>
        <p:spPr>
          <a:xfrm>
            <a:off x="838201" y="5609968"/>
            <a:ext cx="550363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lity of life assessment, emotional functioning score MIS-C and JIA 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S-C- Blue, JIA-Green</a:t>
            </a: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ars represent the number of patients with a particular percentage score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93803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722981-E8AB-CE4E-8957-C99D8B0D82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4. Quality of life assessment social functioning score comparison between MIS-C and JIA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2245753-0C5C-074E-A034-AF692025F5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235678"/>
            <a:ext cx="8130822" cy="52571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2888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E8928-B82B-7545-80D6-7E771BA8DD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4. 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DD56963-9158-3647-A37F-D6AF61F276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904684"/>
            <a:ext cx="5731510" cy="304863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EBF2AFD-3818-4B44-99E7-7B3F1BCC65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186" y="1904682"/>
            <a:ext cx="5731510" cy="33858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BB905B1-6BBA-5340-A384-AF4F306FC6A7}"/>
              </a:ext>
            </a:extLst>
          </p:cNvPr>
          <p:cNvSpPr txBox="1"/>
          <p:nvPr/>
        </p:nvSpPr>
        <p:spPr>
          <a:xfrm>
            <a:off x="838202" y="5726921"/>
            <a:ext cx="483561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lity of life assessment, social functioning score MIS-C and JIA 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S-C- Blue, JIA-Green</a:t>
            </a: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ars represent the number of patients with a particular percentage score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28766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B00FE9-C699-1B47-B817-E23E68023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5. Quality of life assessment school functioning score comparison between MIS-C and JIA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ECA25C3-5229-6140-A1E0-A4B9552300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1" y="1210964"/>
            <a:ext cx="9311435" cy="5281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76971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7229D-C3B2-8D40-A775-CB3FECAC11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5. </a:t>
            </a:r>
            <a:br>
              <a:rPr lang="en-MW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MW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B38CEC0-A199-FA46-B3BE-E1DD06CD40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95711"/>
            <a:ext cx="5731510" cy="366657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B6BA8FA-E6CA-F04D-A71A-C2E21883308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1510" y="2081958"/>
            <a:ext cx="6395800" cy="26940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659F87A-D9B4-EE45-9AFE-0DD1BB6DD7D9}"/>
              </a:ext>
            </a:extLst>
          </p:cNvPr>
          <p:cNvSpPr txBox="1"/>
          <p:nvPr/>
        </p:nvSpPr>
        <p:spPr>
          <a:xfrm>
            <a:off x="555988" y="5353477"/>
            <a:ext cx="573151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lity of life assessment, school functioning score MIS-C and JIA 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S-C- Blue, JIA-Green</a:t>
            </a:r>
          </a:p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ars represent the number of patients with a particular percentage score</a:t>
            </a:r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MW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MW" sz="1100" dirty="0"/>
          </a:p>
        </p:txBody>
      </p:sp>
    </p:spTree>
    <p:extLst>
      <p:ext uri="{BB962C8B-B14F-4D97-AF65-F5344CB8AC3E}">
        <p14:creationId xmlns:p14="http://schemas.microsoft.com/office/powerpoint/2010/main" val="180790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DADE6F5DF11498320F717A5AF8F27" ma:contentTypeVersion="17" ma:contentTypeDescription="Create a new document." ma:contentTypeScope="" ma:versionID="dd20de7a420317ec7b16fbb376f1c91a">
  <xsd:schema xmlns:xsd="http://www.w3.org/2001/XMLSchema" xmlns:xs="http://www.w3.org/2001/XMLSchema" xmlns:p="http://schemas.microsoft.com/office/2006/metadata/properties" xmlns:ns2="f5d2bcc1-7d41-47cc-89e7-cca55e41e103" xmlns:ns3="5b6b7e47-3b9c-493b-b39a-d4d859f00d3a" targetNamespace="http://schemas.microsoft.com/office/2006/metadata/properties" ma:root="true" ma:fieldsID="1e4cd66aab4d42088fae7fce9ae594e4" ns2:_="" ns3:_="">
    <xsd:import namespace="f5d2bcc1-7d41-47cc-89e7-cca55e41e103"/>
    <xsd:import namespace="5b6b7e47-3b9c-493b-b39a-d4d859f00d3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5d2bcc1-7d41-47cc-89e7-cca55e41e1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7647c689-50bb-4dac-a5df-ea65e8388fc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b6b7e47-3b9c-493b-b39a-d4d859f00d3a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1" nillable="true" ma:displayName="Taxonomy Catch All Column" ma:hidden="true" ma:list="{b483ed90-5dc9-411e-8cb4-77c7e0a39d5a}" ma:internalName="TaxCatchAll" ma:showField="CatchAllData" ma:web="5b6b7e47-3b9c-493b-b39a-d4d859f00d3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f5d2bcc1-7d41-47cc-89e7-cca55e41e103">
      <Terms xmlns="http://schemas.microsoft.com/office/infopath/2007/PartnerControls"/>
    </lcf76f155ced4ddcb4097134ff3c332f>
    <TaxCatchAll xmlns="5b6b7e47-3b9c-493b-b39a-d4d859f00d3a" xsi:nil="true"/>
  </documentManagement>
</p:properties>
</file>

<file path=customXml/itemProps1.xml><?xml version="1.0" encoding="utf-8"?>
<ds:datastoreItem xmlns:ds="http://schemas.openxmlformats.org/officeDocument/2006/customXml" ds:itemID="{3D2D2FC9-08B5-4BB7-931B-9FD67330E4A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5d2bcc1-7d41-47cc-89e7-cca55e41e103"/>
    <ds:schemaRef ds:uri="5b6b7e47-3b9c-493b-b39a-d4d859f00d3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A20A2AF-A991-4BBD-AEBB-A1990007E43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D20384E-AAB5-489F-A8FB-2F78D93E0AEB}">
  <ds:schemaRefs>
    <ds:schemaRef ds:uri="5b6b7e47-3b9c-493b-b39a-d4d859f00d3a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http://www.w3.org/XML/1998/namespace"/>
    <ds:schemaRef ds:uri="http://schemas.microsoft.com/office/infopath/2007/PartnerControls"/>
    <ds:schemaRef ds:uri="f5d2bcc1-7d41-47cc-89e7-cca55e41e10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715</TotalTime>
  <Words>262</Words>
  <Application>Microsoft Macintosh PowerPoint</Application>
  <PresentationFormat>Widescreen</PresentationFormat>
  <Paragraphs>27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Medium term health and quality of life outcomes in a cohort of children with MIS-C in Cape Town, South Africa.  </vt:lpstr>
      <vt:lpstr>Table 2. Quality of life assessment physical functioning score comparison between MIS-C and JIA  </vt:lpstr>
      <vt:lpstr>Figure 2.  </vt:lpstr>
      <vt:lpstr>Table 3. Quality of life assessment emotional functioning score comparison between MIS-C and JIA </vt:lpstr>
      <vt:lpstr>Figure 3.  </vt:lpstr>
      <vt:lpstr>Table 4. Quality of life assessment social functioning score comparison between MIS-C and JIA </vt:lpstr>
      <vt:lpstr>Figure 4.  </vt:lpstr>
      <vt:lpstr>Table 5. Quality of life assessment school functioning score comparison between MIS-C and JIA </vt:lpstr>
      <vt:lpstr>Figure 5.  </vt:lpstr>
      <vt:lpstr>Table 6. Quality of life assessment psychosocial functioning score comparison between MIS-C and JIA </vt:lpstr>
      <vt:lpstr>Figure 6.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S-C TWO YEARS POST PANDEMIC: A PROSPECTIVE STUDY AT RED CROSS WAR MEMORIAL CHILDREN’S HOSPITAL   QUALITY OF LIFE FOR MIS-C PATIENTS 6 MONTHS POST DISEASE A PROSPECTIVE STUDY AT RED CROSS WAR MEMORIAL CHILDREN’S HOSPITAL’S </dc:title>
  <dc:creator>Frank phoya</dc:creator>
  <cp:lastModifiedBy>Frank phoya</cp:lastModifiedBy>
  <cp:revision>16</cp:revision>
  <dcterms:created xsi:type="dcterms:W3CDTF">2024-05-07T07:40:09Z</dcterms:created>
  <dcterms:modified xsi:type="dcterms:W3CDTF">2024-10-08T18:23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DADE6F5DF11498320F717A5AF8F27</vt:lpwstr>
  </property>
  <property fmtid="{D5CDD505-2E9C-101B-9397-08002B2CF9AE}" pid="3" name="MediaServiceImageTags">
    <vt:lpwstr/>
  </property>
</Properties>
</file>